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62" r:id="rId2"/>
    <p:sldId id="269" r:id="rId3"/>
    <p:sldId id="267" r:id="rId4"/>
    <p:sldId id="276" r:id="rId5"/>
    <p:sldId id="270" r:id="rId6"/>
    <p:sldId id="271" r:id="rId7"/>
    <p:sldId id="277" r:id="rId8"/>
    <p:sldId id="278" r:id="rId9"/>
    <p:sldId id="279" r:id="rId10"/>
    <p:sldId id="282" r:id="rId11"/>
    <p:sldId id="268" r:id="rId12"/>
    <p:sldId id="273" r:id="rId13"/>
    <p:sldId id="283" r:id="rId14"/>
  </p:sldIdLst>
  <p:sldSz cx="9906000" cy="6858000" type="A4"/>
  <p:notesSz cx="6797675" cy="9926638"/>
  <p:defaultTextStyle>
    <a:defPPr>
      <a:defRPr lang="ko-KR"/>
    </a:defPPr>
    <a:lvl1pPr marL="0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963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925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888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851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814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776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2739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1702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010" autoAdjust="0"/>
  </p:normalViewPr>
  <p:slideViewPr>
    <p:cSldViewPr>
      <p:cViewPr>
        <p:scale>
          <a:sx n="90" d="100"/>
          <a:sy n="90" d="100"/>
        </p:scale>
        <p:origin x="-804" y="-306"/>
      </p:cViewPr>
      <p:guideLst>
        <p:guide orient="horz" pos="3133"/>
        <p:guide orient="horz" pos="213"/>
        <p:guide orient="horz" pos="164"/>
        <p:guide pos="3120"/>
        <p:guide pos="50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D42A37-10FD-459B-B77D-09371CE16A6C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711200" y="744538"/>
            <a:ext cx="53752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525214-BB4C-4D15-B380-F3B65CF2EC2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90978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1pPr>
    <a:lvl2pPr marL="106436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2pPr>
    <a:lvl3pPr marL="212872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3pPr>
    <a:lvl4pPr marL="319308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4pPr>
    <a:lvl5pPr marL="425745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5pPr>
    <a:lvl6pPr marL="532181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6pPr>
    <a:lvl7pPr marL="638617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7pPr>
    <a:lvl8pPr marL="745053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8pPr>
    <a:lvl9pPr marL="851489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3525214-BB4C-4D15-B380-F3B65CF2EC2E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21512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89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579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368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158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948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737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527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317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22623862" y="1730375"/>
            <a:ext cx="7020189" cy="368649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1559852" y="1730375"/>
            <a:ext cx="20898908" cy="368649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8963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579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3688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1585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39481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7377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5273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317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1559853" y="10080625"/>
            <a:ext cx="13959549" cy="2851467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15684500" y="10080625"/>
            <a:ext cx="13959550" cy="2851467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63" indent="0">
              <a:buNone/>
              <a:defRPr sz="2100" b="1"/>
            </a:lvl2pPr>
            <a:lvl3pPr marL="957925" indent="0">
              <a:buNone/>
              <a:defRPr sz="1900" b="1"/>
            </a:lvl3pPr>
            <a:lvl4pPr marL="1436888" indent="0">
              <a:buNone/>
              <a:defRPr sz="1700" b="1"/>
            </a:lvl4pPr>
            <a:lvl5pPr marL="1915851" indent="0">
              <a:buNone/>
              <a:defRPr sz="1700" b="1"/>
            </a:lvl5pPr>
            <a:lvl6pPr marL="2394814" indent="0">
              <a:buNone/>
              <a:defRPr sz="1700" b="1"/>
            </a:lvl6pPr>
            <a:lvl7pPr marL="2873776" indent="0">
              <a:buNone/>
              <a:defRPr sz="1700" b="1"/>
            </a:lvl7pPr>
            <a:lvl8pPr marL="3352739" indent="0">
              <a:buNone/>
              <a:defRPr sz="1700" b="1"/>
            </a:lvl8pPr>
            <a:lvl9pPr marL="3831702" indent="0">
              <a:buNone/>
              <a:defRPr sz="17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89" cy="63976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63" indent="0">
              <a:buNone/>
              <a:defRPr sz="2100" b="1"/>
            </a:lvl2pPr>
            <a:lvl3pPr marL="957925" indent="0">
              <a:buNone/>
              <a:defRPr sz="1900" b="1"/>
            </a:lvl3pPr>
            <a:lvl4pPr marL="1436888" indent="0">
              <a:buNone/>
              <a:defRPr sz="1700" b="1"/>
            </a:lvl4pPr>
            <a:lvl5pPr marL="1915851" indent="0">
              <a:buNone/>
              <a:defRPr sz="1700" b="1"/>
            </a:lvl5pPr>
            <a:lvl6pPr marL="2394814" indent="0">
              <a:buNone/>
              <a:defRPr sz="1700" b="1"/>
            </a:lvl6pPr>
            <a:lvl7pPr marL="2873776" indent="0">
              <a:buNone/>
              <a:defRPr sz="1700" b="1"/>
            </a:lvl7pPr>
            <a:lvl8pPr marL="3352739" indent="0">
              <a:buNone/>
              <a:defRPr sz="1700" b="1"/>
            </a:lvl8pPr>
            <a:lvl9pPr marL="3831702" indent="0">
              <a:buNone/>
              <a:defRPr sz="17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89" cy="3951288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1" y="273051"/>
            <a:ext cx="3259006" cy="1162050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30" cy="5853113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95301" y="1435101"/>
            <a:ext cx="3259006" cy="4691063"/>
          </a:xfrm>
        </p:spPr>
        <p:txBody>
          <a:bodyPr/>
          <a:lstStyle>
            <a:lvl1pPr marL="0" indent="0">
              <a:buNone/>
              <a:defRPr sz="1500"/>
            </a:lvl1pPr>
            <a:lvl2pPr marL="478963" indent="0">
              <a:buNone/>
              <a:defRPr sz="1300"/>
            </a:lvl2pPr>
            <a:lvl3pPr marL="957925" indent="0">
              <a:buNone/>
              <a:defRPr sz="1000"/>
            </a:lvl3pPr>
            <a:lvl4pPr marL="1436888" indent="0">
              <a:buNone/>
              <a:defRPr sz="1000"/>
            </a:lvl4pPr>
            <a:lvl5pPr marL="1915851" indent="0">
              <a:buNone/>
              <a:defRPr sz="1000"/>
            </a:lvl5pPr>
            <a:lvl6pPr marL="2394814" indent="0">
              <a:buNone/>
              <a:defRPr sz="1000"/>
            </a:lvl6pPr>
            <a:lvl7pPr marL="2873776" indent="0">
              <a:buNone/>
              <a:defRPr sz="1000"/>
            </a:lvl7pPr>
            <a:lvl8pPr marL="3352739" indent="0">
              <a:buNone/>
              <a:defRPr sz="1000"/>
            </a:lvl8pPr>
            <a:lvl9pPr marL="3831702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400"/>
            </a:lvl1pPr>
            <a:lvl2pPr marL="478963" indent="0">
              <a:buNone/>
              <a:defRPr sz="2900"/>
            </a:lvl2pPr>
            <a:lvl3pPr marL="957925" indent="0">
              <a:buNone/>
              <a:defRPr sz="2500"/>
            </a:lvl3pPr>
            <a:lvl4pPr marL="1436888" indent="0">
              <a:buNone/>
              <a:defRPr sz="2100"/>
            </a:lvl4pPr>
            <a:lvl5pPr marL="1915851" indent="0">
              <a:buNone/>
              <a:defRPr sz="2100"/>
            </a:lvl5pPr>
            <a:lvl6pPr marL="2394814" indent="0">
              <a:buNone/>
              <a:defRPr sz="2100"/>
            </a:lvl6pPr>
            <a:lvl7pPr marL="2873776" indent="0">
              <a:buNone/>
              <a:defRPr sz="2100"/>
            </a:lvl7pPr>
            <a:lvl8pPr marL="3352739" indent="0">
              <a:buNone/>
              <a:defRPr sz="2100"/>
            </a:lvl8pPr>
            <a:lvl9pPr marL="3831702" indent="0">
              <a:buNone/>
              <a:defRPr sz="21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500"/>
            </a:lvl1pPr>
            <a:lvl2pPr marL="478963" indent="0">
              <a:buNone/>
              <a:defRPr sz="1300"/>
            </a:lvl2pPr>
            <a:lvl3pPr marL="957925" indent="0">
              <a:buNone/>
              <a:defRPr sz="1000"/>
            </a:lvl3pPr>
            <a:lvl4pPr marL="1436888" indent="0">
              <a:buNone/>
              <a:defRPr sz="1000"/>
            </a:lvl4pPr>
            <a:lvl5pPr marL="1915851" indent="0">
              <a:buNone/>
              <a:defRPr sz="1000"/>
            </a:lvl5pPr>
            <a:lvl6pPr marL="2394814" indent="0">
              <a:buNone/>
              <a:defRPr sz="1000"/>
            </a:lvl6pPr>
            <a:lvl7pPr marL="2873776" indent="0">
              <a:buNone/>
              <a:defRPr sz="1000"/>
            </a:lvl7pPr>
            <a:lvl8pPr marL="3352739" indent="0">
              <a:buNone/>
              <a:defRPr sz="1000"/>
            </a:lvl8pPr>
            <a:lvl9pPr marL="3831702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5793" tIns="47896" rIns="95793" bIns="47896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5793" tIns="47896" rIns="95793" bIns="47896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5793" tIns="47896" rIns="95793" bIns="47896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5793" tIns="47896" rIns="95793" bIns="47896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5793" tIns="47896" rIns="95793" bIns="47896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57925" rtl="0" eaLnBrk="1" latinLnBrk="1" hangingPunct="1">
        <a:spcBef>
          <a:spcPct val="0"/>
        </a:spcBef>
        <a:buNone/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222" indent="-359222" algn="l" defTabSz="957925" rtl="0" eaLnBrk="1" latinLnBrk="1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78314" indent="-299352" algn="l" defTabSz="957925" rtl="0" eaLnBrk="1" latinLnBrk="1" hangingPunct="1">
        <a:spcBef>
          <a:spcPct val="20000"/>
        </a:spcBef>
        <a:buFont typeface="Arial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97407" indent="-239481" algn="l" defTabSz="957925" rtl="0" eaLnBrk="1" latinLnBrk="1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76370" indent="-239481" algn="l" defTabSz="957925" rtl="0" eaLnBrk="1" latinLnBrk="1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5332" indent="-239481" algn="l" defTabSz="957925" rtl="0" eaLnBrk="1" latinLnBrk="1" hangingPunct="1">
        <a:spcBef>
          <a:spcPct val="20000"/>
        </a:spcBef>
        <a:buFont typeface="Arial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34295" indent="-239481" algn="l" defTabSz="957925" rtl="0" eaLnBrk="1" latinLnBrk="1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13258" indent="-239481" algn="l" defTabSz="957925" rtl="0" eaLnBrk="1" latinLnBrk="1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92220" indent="-239481" algn="l" defTabSz="957925" rtl="0" eaLnBrk="1" latinLnBrk="1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71183" indent="-239481" algn="l" defTabSz="957925" rtl="0" eaLnBrk="1" latinLnBrk="1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8963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57925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888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15851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94814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3776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52739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31702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1965" y="4382777"/>
            <a:ext cx="6634881" cy="1794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1642783" y="527290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62118" y="136947"/>
            <a:ext cx="8958283" cy="267717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</a:t>
            </a:r>
            <a:r>
              <a:rPr lang="en-US" altLang="ko-KR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ure. Human proteins identified 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rom </a:t>
            </a:r>
            <a:r>
              <a:rPr lang="en-US" altLang="ko-KR" sz="16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nd HFDB searches of Calu-1 </a:t>
            </a:r>
            <a:r>
              <a:rPr lang="en-US" altLang="ko-KR" sz="16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cretome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.</a:t>
            </a:r>
            <a:r>
              <a:rPr lang="en-US" altLang="ko-KR" sz="11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</a:p>
        </p:txBody>
      </p:sp>
      <p:sp>
        <p:nvSpPr>
          <p:cNvPr id="3" name="타원 2"/>
          <p:cNvSpPr/>
          <p:nvPr/>
        </p:nvSpPr>
        <p:spPr>
          <a:xfrm>
            <a:off x="3306755" y="2175047"/>
            <a:ext cx="2297341" cy="2165539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타원 6"/>
          <p:cNvSpPr/>
          <p:nvPr/>
        </p:nvSpPr>
        <p:spPr>
          <a:xfrm>
            <a:off x="3820750" y="2198171"/>
            <a:ext cx="2297341" cy="2165539"/>
          </a:xfrm>
          <a:prstGeom prst="ellips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TextBox 3"/>
          <p:cNvSpPr txBox="1"/>
          <p:nvPr/>
        </p:nvSpPr>
        <p:spPr>
          <a:xfrm>
            <a:off x="3388702" y="3063195"/>
            <a:ext cx="4825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416692" y="3063195"/>
            <a:ext cx="6760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396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695393" y="3055542"/>
            <a:ext cx="6760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279"/>
          <a:stretch/>
        </p:blipFill>
        <p:spPr bwMode="auto">
          <a:xfrm>
            <a:off x="3233867" y="741750"/>
            <a:ext cx="5886535" cy="12055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1" name="직선 화살표 연결선 10"/>
          <p:cNvCxnSpPr/>
          <p:nvPr/>
        </p:nvCxnSpPr>
        <p:spPr>
          <a:xfrm flipV="1">
            <a:off x="5889104" y="1971015"/>
            <a:ext cx="0" cy="100811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화살표 연결선 15"/>
          <p:cNvCxnSpPr/>
          <p:nvPr/>
        </p:nvCxnSpPr>
        <p:spPr>
          <a:xfrm rot="10800000" flipV="1">
            <a:off x="3522780" y="3513000"/>
            <a:ext cx="0" cy="1008112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2144688" y="468263"/>
            <a:ext cx="7488832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Venn diagram showing the number of common proteins and the proteins 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dentified exclusively from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search (detailed in B) or HFDB search (detailed in C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946715" y="2092786"/>
            <a:ext cx="11918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uDB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817096" y="3841170"/>
            <a:ext cx="11918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FDB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2337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80598" y="431513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soform 13 of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alumenin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(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man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) in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 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none in HFDB</a:t>
            </a:r>
            <a:endParaRPr lang="en-US" altLang="ko-KR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102668" y="3222838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DGDKDGFVTVDELKDWIK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8744" y="3539232"/>
            <a:ext cx="9000000" cy="2895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10" t="33287" r="1474" b="41918"/>
          <a:stretch/>
        </p:blipFill>
        <p:spPr bwMode="auto">
          <a:xfrm>
            <a:off x="830438" y="898835"/>
            <a:ext cx="9000000" cy="1662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794002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C</a:t>
            </a:r>
            <a:endParaRPr lang="en-US" altLang="ko-KR" sz="2000" b="1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2560" y="709169"/>
            <a:ext cx="8607305" cy="12591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080598" y="431513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he list is solely identified human protein groups in HFDB. None of  PSMs were matched to bovine protein groups in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933915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C</a:t>
            </a:r>
            <a:endParaRPr lang="en-US" altLang="ko-KR" sz="2000" b="1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080598" y="423163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adherin EGF LAG seven-pass G-type receptor 1 (Fragment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) (Human) in HFDB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 none in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HuDB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0081" y="3645023"/>
            <a:ext cx="9000000" cy="2895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219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89" t="33522" r="1602" b="24657"/>
          <a:stretch/>
        </p:blipFill>
        <p:spPr bwMode="auto">
          <a:xfrm>
            <a:off x="910607" y="709169"/>
            <a:ext cx="8208912" cy="255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102668" y="3412119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NDPDEGPNAQImYQIVEGDmR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7926916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C</a:t>
            </a:r>
            <a:endParaRPr lang="en-US" altLang="ko-KR" sz="2000" b="1" dirty="0" smtClean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080598" y="423163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Q and AAA domain-containing protein 1 (Fragment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) (Human) in HFDB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 none in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HuDB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02668" y="3412119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YNKMWHQTQEALGALLDK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0308" y="3643144"/>
            <a:ext cx="9000000" cy="2895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94" t="33736" r="1564" b="35450"/>
          <a:stretch/>
        </p:blipFill>
        <p:spPr bwMode="auto">
          <a:xfrm>
            <a:off x="844246" y="759968"/>
            <a:ext cx="8871669" cy="20209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187232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080598" y="431513"/>
            <a:ext cx="8398967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he list is solely identified human protein groups in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. But, almost all PSMs were matched to bovine protein groups in HFDB  </a:t>
            </a: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7787" y="953345"/>
            <a:ext cx="8335693" cy="28210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933915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00" t="25373" r="6896" b="29103"/>
          <a:stretch/>
        </p:blipFill>
        <p:spPr bwMode="auto">
          <a:xfrm>
            <a:off x="976919" y="3775670"/>
            <a:ext cx="8287644" cy="27610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9" t="25809" r="7737" b="28857"/>
          <a:stretch/>
        </p:blipFill>
        <p:spPr bwMode="auto">
          <a:xfrm>
            <a:off x="976919" y="709169"/>
            <a:ext cx="8202338" cy="27495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080598" y="431513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Plasminogen (Human) in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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Plasminogen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Bovine) in HFDB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</a:p>
        </p:txBody>
      </p:sp>
      <p:sp>
        <p:nvSpPr>
          <p:cNvPr id="2" name="직사각형 1"/>
          <p:cNvSpPr/>
          <p:nvPr/>
        </p:nvSpPr>
        <p:spPr>
          <a:xfrm>
            <a:off x="976919" y="2825693"/>
            <a:ext cx="121219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n </a:t>
            </a:r>
            <a:r>
              <a:rPr lang="en-US" altLang="ko-KR" sz="20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endParaRPr lang="ko-KR" altLang="en-US" dirty="0"/>
          </a:p>
        </p:txBody>
      </p:sp>
      <p:sp>
        <p:nvSpPr>
          <p:cNvPr id="10" name="직사각형 9"/>
          <p:cNvSpPr/>
          <p:nvPr/>
        </p:nvSpPr>
        <p:spPr>
          <a:xfrm>
            <a:off x="992560" y="6021288"/>
            <a:ext cx="122661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n </a:t>
            </a:r>
            <a:r>
              <a:rPr lang="en-US" altLang="ko-KR" sz="2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FDB </a:t>
            </a:r>
            <a:endParaRPr lang="ko-KR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933915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80598" y="431513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PENYPNAGLTMNYcR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2581" y="980728"/>
            <a:ext cx="8856984" cy="2849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4073569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80598" y="431513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Eukaryotic translation initiation factor 3 subunit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D (Human) in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 none in HFDB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02" t="25524" r="8214" b="40381"/>
          <a:stretch/>
        </p:blipFill>
        <p:spPr bwMode="auto">
          <a:xfrm>
            <a:off x="780802" y="709169"/>
            <a:ext cx="8928992" cy="22683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5073" y="3699852"/>
            <a:ext cx="8335892" cy="26814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079489" y="3408382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NLAMEATYINHNFSQQcLR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7926916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80598" y="431513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ubulin 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eta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hain (Human) in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 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Tubulin beta chain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Bovine) 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n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FDB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 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4100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76" t="32977" r="1544" b="35771"/>
          <a:stretch/>
        </p:blipFill>
        <p:spPr bwMode="auto">
          <a:xfrm>
            <a:off x="852686" y="836712"/>
            <a:ext cx="8695284" cy="2008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38" t="33707" r="1797" b="33147"/>
          <a:stretch/>
        </p:blipFill>
        <p:spPr bwMode="auto">
          <a:xfrm>
            <a:off x="852686" y="3858766"/>
            <a:ext cx="8543696" cy="20905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직사각형 9"/>
          <p:cNvSpPr/>
          <p:nvPr/>
        </p:nvSpPr>
        <p:spPr>
          <a:xfrm>
            <a:off x="976919" y="2348880"/>
            <a:ext cx="1212191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n </a:t>
            </a:r>
            <a:r>
              <a:rPr lang="en-US" altLang="ko-KR" sz="20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endParaRPr lang="ko-KR" altLang="en-US" dirty="0"/>
          </a:p>
        </p:txBody>
      </p:sp>
      <p:sp>
        <p:nvSpPr>
          <p:cNvPr id="11" name="직사각형 10"/>
          <p:cNvSpPr/>
          <p:nvPr/>
        </p:nvSpPr>
        <p:spPr>
          <a:xfrm>
            <a:off x="992560" y="5544475"/>
            <a:ext cx="122661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0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n </a:t>
            </a:r>
            <a:r>
              <a:rPr lang="en-US" altLang="ko-KR" sz="20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FDB </a:t>
            </a:r>
            <a:endParaRPr lang="ko-KR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7926916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80598" y="431513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HYTEGAELVDSVLDVVRK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8524" y="637675"/>
            <a:ext cx="9000000" cy="30020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080598" y="3789040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HYTEGAELVDSVLDVVR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9544" y="4049459"/>
            <a:ext cx="9000000" cy="28951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41803949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080598" y="431513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LTTPTYGDLNHLVSATMSGVTTcLR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7448" y="641123"/>
            <a:ext cx="9000000" cy="2895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091727" y="3645024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LTTPTYGDLNHLVSATMSGVTTcLR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9544" y="3789040"/>
            <a:ext cx="9000000" cy="2895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7813339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80598" y="431513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soform 2 of Microtubule-associated protein RP/EB family member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2 (Human) in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 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  <a:sym typeface="Wingdings" panose="05000000000000000000" pitchFamily="2" charset="2"/>
              </a:rPr>
              <a:t>none in HFDB</a:t>
            </a:r>
            <a:endParaRPr lang="en-US" altLang="ko-KR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2961" y="3479800"/>
            <a:ext cx="9000000" cy="2895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11" t="33411" r="2015" b="37182"/>
          <a:stretch/>
        </p:blipFill>
        <p:spPr bwMode="auto">
          <a:xfrm>
            <a:off x="743628" y="908720"/>
            <a:ext cx="9000000" cy="19699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102668" y="3222838"/>
            <a:ext cx="8398967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DKDLETQVIQLNEQVmHQLWPR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54478" y="4512"/>
            <a:ext cx="1342138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692219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19050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tx1"/>
          </a:solidFill>
          <a:tailEnd type="arrow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7</TotalTime>
  <Words>266</Words>
  <Application>Microsoft Office PowerPoint</Application>
  <PresentationFormat>A4 용지(210x297mm)</PresentationFormat>
  <Paragraphs>56</Paragraphs>
  <Slides>13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3</vt:i4>
      </vt:variant>
    </vt:vector>
  </HeadingPairs>
  <TitlesOfParts>
    <vt:vector size="14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kis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지혜</dc:creator>
  <cp:lastModifiedBy>CLee</cp:lastModifiedBy>
  <cp:revision>272</cp:revision>
  <cp:lastPrinted>2013-11-07T11:22:44Z</cp:lastPrinted>
  <dcterms:created xsi:type="dcterms:W3CDTF">2011-04-20T01:16:28Z</dcterms:created>
  <dcterms:modified xsi:type="dcterms:W3CDTF">2015-01-21T08:54:08Z</dcterms:modified>
</cp:coreProperties>
</file>